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7"/>
    <p:restoredTop sz="95921"/>
  </p:normalViewPr>
  <p:slideViewPr>
    <p:cSldViewPr snapToGrid="0">
      <p:cViewPr varScale="1">
        <p:scale>
          <a:sx n="75" d="100"/>
          <a:sy n="75" d="100"/>
        </p:scale>
        <p:origin x="176" y="10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F1F058D-99A7-C68A-2FC0-75DB1430D06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D2DD4653-AF2D-202F-0F9E-7352E36C14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F14373B-57F1-0800-CBCD-167280101E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D1C13-B557-7B46-8FD3-1F94CF434D63}" type="datetimeFigureOut">
              <a:rPr lang="it-IT" smtClean="0"/>
              <a:t>22/12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40C530E-9139-256B-1E83-B392279F90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A22EC47-55D4-88D0-88FF-6E8F177391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41AB1-DFE5-9846-914A-B1D7308D3B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26214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01CC28F-3F10-70B7-798D-D44741B3F6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DA534DA-4FA2-4D77-9FD4-4CAE4548B0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BBF4190-2909-558B-A4B6-BCBA8778A0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D1C13-B557-7B46-8FD3-1F94CF434D63}" type="datetimeFigureOut">
              <a:rPr lang="it-IT" smtClean="0"/>
              <a:t>22/12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862C941-AA7A-6223-3911-BA72461303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1770129-9EEC-7E08-AC64-AEEAF36431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41AB1-DFE5-9846-914A-B1D7308D3B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83339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E10D995D-5910-9359-3FB7-0AA54B038AF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A23E981-E92D-6317-E68C-72B07B47D7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242087B-8DAC-F6E1-22F2-350FDF2A42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D1C13-B557-7B46-8FD3-1F94CF434D63}" type="datetimeFigureOut">
              <a:rPr lang="it-IT" smtClean="0"/>
              <a:t>22/12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C3058E3-9A96-6B37-B5F2-454FE73225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C3C37B9-B776-E4BC-E67F-50444FA98D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41AB1-DFE5-9846-914A-B1D7308D3B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396751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4C322E3-38CE-5321-9228-538C3433A4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4FD63EF-F99C-73FC-FB4E-22DFB2EC768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511E09E-6B9A-03DB-BCEC-B0BA46ED6F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D1C13-B557-7B46-8FD3-1F94CF434D63}" type="datetimeFigureOut">
              <a:rPr lang="it-IT" smtClean="0"/>
              <a:t>22/12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76365DE-D7D1-3889-F1EC-EC8A288A58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189C273-9D5F-1746-2473-69A2B31D64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41AB1-DFE5-9846-914A-B1D7308D3B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569992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5ECBF3B-DC36-8EA2-A23A-42A91A3395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95E51FC-40DB-915B-EB66-791968A2F1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6A16987-EBFD-E970-7E3C-785A2987C3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D1C13-B557-7B46-8FD3-1F94CF434D63}" type="datetimeFigureOut">
              <a:rPr lang="it-IT" smtClean="0"/>
              <a:t>22/12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621CC94-BCE6-C4C9-503C-E8F7606409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2E68832-A1BD-3C7B-09DD-08313179D4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41AB1-DFE5-9846-914A-B1D7308D3B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427711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BF23241-3BA7-C387-DF79-5E54FFADE9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94132D0-269D-FA60-EF69-CC175335B6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693C249-617A-3CBB-E625-E16FF2414B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C73FE57-DFDD-67E5-7E5D-35EE99F069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D1C13-B557-7B46-8FD3-1F94CF434D63}" type="datetimeFigureOut">
              <a:rPr lang="it-IT" smtClean="0"/>
              <a:t>22/12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437711F-06A7-7457-83A1-5A9CAF00D1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7E38617-5F77-EFB9-E347-117F2850AA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41AB1-DFE5-9846-914A-B1D7308D3B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85044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A4591F6-5790-5BAB-E674-517F02EE74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BA05019-E10D-6C87-4CC9-3C73771C93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87C3EBD9-6DBF-19E3-E7BE-4617B77F18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0750232B-1A01-B3D5-FF97-6DA78EABEB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7952C02E-515B-FF4F-12DF-BAE92B206C4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24595F1E-579C-F988-65DD-7B3377207F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D1C13-B557-7B46-8FD3-1F94CF434D63}" type="datetimeFigureOut">
              <a:rPr lang="it-IT" smtClean="0"/>
              <a:t>22/12/22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482430F1-B057-A65E-4300-DA32ECC980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7F85D285-2A52-327D-5597-ADDD69F9B7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41AB1-DFE5-9846-914A-B1D7308D3B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680732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007F42C-02C8-5FEE-A89F-93CE5BBEA7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DE9854F6-3DA6-7622-6446-59EB7DA464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D1C13-B557-7B46-8FD3-1F94CF434D63}" type="datetimeFigureOut">
              <a:rPr lang="it-IT" smtClean="0"/>
              <a:t>22/12/22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FACE4B8C-4213-BD7A-6F58-CD6D114BCB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082F6BE6-32E0-1BD1-234C-CDB07EB584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41AB1-DFE5-9846-914A-B1D7308D3B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088643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CCB00937-60E5-496D-5AD3-1AEA3F85E0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D1C13-B557-7B46-8FD3-1F94CF434D63}" type="datetimeFigureOut">
              <a:rPr lang="it-IT" smtClean="0"/>
              <a:t>22/12/22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A92CDE9-23C3-B9CA-5022-FE3ECE803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7DD470FC-04AA-C832-3626-53878F7AE6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41AB1-DFE5-9846-914A-B1D7308D3B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882346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E218156-DDCA-0149-9A33-AC97B9E96B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AD5B640-B995-7A4B-7CC8-E3FF6BADEF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F34C7EB-C9F8-5729-5004-D6C33C5E8B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3C8F732-5E94-382E-FA36-94CDAF69D2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D1C13-B557-7B46-8FD3-1F94CF434D63}" type="datetimeFigureOut">
              <a:rPr lang="it-IT" smtClean="0"/>
              <a:t>22/12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D6DA139-FB7D-0B5D-11B1-EFEEA628DC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E07E50B-035A-C8B7-272E-78B3AE21C1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41AB1-DFE5-9846-914A-B1D7308D3B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782470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4199AC6-2AFD-EE43-D492-BA66DFA4CE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1C148774-708B-B564-B184-0FBAC8AA434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E92B323-0135-4661-4B52-267719B7DC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32485FE-4BA2-B214-6590-EA8479E96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D1C13-B557-7B46-8FD3-1F94CF434D63}" type="datetimeFigureOut">
              <a:rPr lang="it-IT" smtClean="0"/>
              <a:t>22/12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6582B0E-52B6-7C18-D46E-72ABC35FE7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C9EED09-D5D7-5D72-60A0-B7E6B623E4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41AB1-DFE5-9846-914A-B1D7308D3B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62546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8E9EC470-0283-4D5C-E11B-9C3C276B00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243ACFF-D560-81E2-92EB-338C8620DD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8EB7291-9B62-0E7D-75DC-570C79AC935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0D1C13-B557-7B46-8FD3-1F94CF434D63}" type="datetimeFigureOut">
              <a:rPr lang="it-IT" smtClean="0"/>
              <a:t>22/12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9479C56-C1C4-8D6F-3A34-65E2DB43EC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A40245B-A94A-16EE-68C9-2097E90616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641AB1-DFE5-9846-914A-B1D7308D3B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9588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7F6A684E-B2E6-7734-EBEA-44BF68C3EC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3850" y="12700"/>
            <a:ext cx="6261100" cy="6845300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79AAC857-0600-0DC7-D208-32FC52718C3D}"/>
              </a:ext>
            </a:extLst>
          </p:cNvPr>
          <p:cNvSpPr txBox="1"/>
          <p:nvPr/>
        </p:nvSpPr>
        <p:spPr>
          <a:xfrm>
            <a:off x="4180417" y="49431"/>
            <a:ext cx="24045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S3-ZetaPals </a:t>
            </a:r>
            <a:r>
              <a:rPr lang="it-IT" b="1" dirty="0" err="1"/>
              <a:t>Particle</a:t>
            </a:r>
            <a:r>
              <a:rPr lang="it-IT" b="1" dirty="0"/>
              <a:t> and </a:t>
            </a:r>
            <a:r>
              <a:rPr lang="it-IT" b="1" dirty="0" err="1"/>
              <a:t>Polydispersity</a:t>
            </a:r>
            <a:endParaRPr lang="it-IT" b="1" dirty="0"/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D62BCCEE-E935-9751-C103-F67E9CDDC772}"/>
              </a:ext>
            </a:extLst>
          </p:cNvPr>
          <p:cNvSpPr txBox="1"/>
          <p:nvPr/>
        </p:nvSpPr>
        <p:spPr>
          <a:xfrm>
            <a:off x="6976533" y="86161"/>
            <a:ext cx="38777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/>
              <a:t>All</a:t>
            </a:r>
            <a:r>
              <a:rPr lang="it-IT" dirty="0"/>
              <a:t> data are </a:t>
            </a:r>
            <a:r>
              <a:rPr lang="it-IT" dirty="0" err="1"/>
              <a:t>reported</a:t>
            </a:r>
            <a:r>
              <a:rPr lang="it-IT" dirty="0"/>
              <a:t> in </a:t>
            </a:r>
            <a:r>
              <a:rPr lang="it-IT" dirty="0" err="1"/>
              <a:t>previous</a:t>
            </a:r>
            <a:r>
              <a:rPr lang="it-IT" dirty="0"/>
              <a:t> work : </a:t>
            </a:r>
            <a:r>
              <a:rPr lang="it-IT" dirty="0" err="1"/>
              <a:t>reference</a:t>
            </a:r>
            <a:r>
              <a:rPr lang="it-IT" dirty="0"/>
              <a:t> 12 in the </a:t>
            </a:r>
            <a:r>
              <a:rPr lang="it-IT" dirty="0" err="1"/>
              <a:t>manuscript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5995898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0BDEC43F-615C-CED5-3E39-57539B8994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5067" y="274585"/>
            <a:ext cx="10425230" cy="6308829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B5376FBF-0810-D9DB-2EF7-E7C045DF460A}"/>
              </a:ext>
            </a:extLst>
          </p:cNvPr>
          <p:cNvSpPr txBox="1"/>
          <p:nvPr/>
        </p:nvSpPr>
        <p:spPr>
          <a:xfrm>
            <a:off x="7484534" y="524933"/>
            <a:ext cx="2912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S3- XRD Data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25F76A8E-1FE4-0DAC-7355-BEC186617F25}"/>
              </a:ext>
            </a:extLst>
          </p:cNvPr>
          <p:cNvSpPr txBox="1"/>
          <p:nvPr/>
        </p:nvSpPr>
        <p:spPr>
          <a:xfrm>
            <a:off x="7001933" y="5686736"/>
            <a:ext cx="38777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/>
              <a:t>All</a:t>
            </a:r>
            <a:r>
              <a:rPr lang="it-IT" dirty="0"/>
              <a:t> data are </a:t>
            </a:r>
            <a:r>
              <a:rPr lang="it-IT" dirty="0" err="1"/>
              <a:t>reported</a:t>
            </a:r>
            <a:r>
              <a:rPr lang="it-IT" dirty="0"/>
              <a:t> in </a:t>
            </a:r>
            <a:r>
              <a:rPr lang="it-IT" dirty="0" err="1"/>
              <a:t>previous</a:t>
            </a:r>
            <a:r>
              <a:rPr lang="it-IT" dirty="0"/>
              <a:t> work : </a:t>
            </a:r>
            <a:r>
              <a:rPr lang="it-IT" dirty="0" err="1"/>
              <a:t>reference</a:t>
            </a:r>
            <a:r>
              <a:rPr lang="it-IT" dirty="0"/>
              <a:t> 12 in the </a:t>
            </a:r>
            <a:r>
              <a:rPr lang="it-IT" dirty="0" err="1"/>
              <a:t>manuscript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65206200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 2013-2022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33</Words>
  <Application>Microsoft Macintosh PowerPoint</Application>
  <PresentationFormat>Widescreen</PresentationFormat>
  <Paragraphs>4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i Office 2013-2022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uca Scotti</dc:creator>
  <cp:lastModifiedBy>Luca Scotti</cp:lastModifiedBy>
  <cp:revision>2</cp:revision>
  <dcterms:created xsi:type="dcterms:W3CDTF">2022-12-22T06:38:15Z</dcterms:created>
  <dcterms:modified xsi:type="dcterms:W3CDTF">2022-12-22T08:04:03Z</dcterms:modified>
</cp:coreProperties>
</file>